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handoutMasterIdLst>
    <p:handoutMasterId r:id="rId13"/>
  </p:handoutMasterIdLst>
  <p:sldIdLst>
    <p:sldId id="334" r:id="rId2"/>
    <p:sldId id="321" r:id="rId3"/>
    <p:sldId id="318" r:id="rId4"/>
    <p:sldId id="325" r:id="rId5"/>
    <p:sldId id="326" r:id="rId6"/>
    <p:sldId id="327" r:id="rId7"/>
    <p:sldId id="328" r:id="rId8"/>
    <p:sldId id="331" r:id="rId9"/>
    <p:sldId id="333" r:id="rId10"/>
    <p:sldId id="332" r:id="rId11"/>
  </p:sldIdLst>
  <p:sldSz cx="9144000" cy="5715000" type="screen16x1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  <p15:guide id="3" orient="horz" pos="3599">
          <p15:clr>
            <a:srgbClr val="A4A3A4"/>
          </p15:clr>
        </p15:guide>
        <p15:guide id="4" pos="462">
          <p15:clr>
            <a:srgbClr val="A4A3A4"/>
          </p15:clr>
        </p15:guide>
        <p15:guide id="5" orient="horz" pos="358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DBED569-4797-4DF1-A0F4-6AAB3CD982D8}" styleName="浅色样式 3 - 强调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浅色样式 3 - 强调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BC89EF96-8CEA-46FF-86C4-4CE0E7609802}" styleName="Helle Formatvorlage 3 - Akz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16"/>
    <p:restoredTop sz="94626"/>
  </p:normalViewPr>
  <p:slideViewPr>
    <p:cSldViewPr snapToGrid="0" snapToObjects="1">
      <p:cViewPr varScale="1">
        <p:scale>
          <a:sx n="100" d="100"/>
          <a:sy n="100" d="100"/>
        </p:scale>
        <p:origin x="1088" y="168"/>
      </p:cViewPr>
      <p:guideLst>
        <p:guide orient="horz" pos="2160"/>
        <p:guide pos="3840"/>
        <p:guide orient="horz" pos="3599"/>
        <p:guide pos="462"/>
        <p:guide orient="horz" pos="358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8" d="100"/>
        <a:sy n="158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35149D-3DFB-FF4E-B290-43AAD6BEDC82}" type="datetimeFigureOut">
              <a:rPr lang="de-DE" smtClean="0"/>
              <a:t>03.12.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64A377-F93E-B94E-8CA8-228EF26BD05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675179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C3373D-BA9C-2443-876C-77EB6E1F0311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960438" y="1143000"/>
            <a:ext cx="49371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47DB79-8D35-5341-936B-D882BFE51A91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93097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A96370-7067-944F-B474-63E89BA2FC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935302"/>
            <a:ext cx="6858000" cy="19896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7E47280-DE55-4842-87EF-0F34A34BF6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001698"/>
            <a:ext cx="6858000" cy="137980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2EE07AC-672A-E242-B6DB-62C4C4595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FC6224-8526-9C42-B828-C9A966A6F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23C06CE-BE39-7A4A-ABD1-63CE3E870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546471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EA3214-A8D3-4B4B-BB69-72774A8C4B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DD68B7C-02B0-4947-845E-AD69B8D769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9DBCD7-0A5A-5F4F-851C-F68529BF6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72A4686-4623-4948-AFCA-DA9B237F93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A1BD12-C222-5F4D-99F5-F7CC58E01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95526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8FEC944-100C-404D-AA41-89D410499C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6" y="304271"/>
            <a:ext cx="1971675" cy="484319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A5A8B64-64B4-EC40-A163-76886BD757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1" y="304271"/>
            <a:ext cx="5800725" cy="4843198"/>
          </a:xfrm>
        </p:spPr>
        <p:txBody>
          <a:bodyPr vert="eaVert"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CF1159-E2C8-084F-B544-1BAC89EF97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8432D0-18F3-A84C-8286-BE574173F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CAC70A-E83E-6540-83D1-94097975A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674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FE6AEE-5FEB-9341-A88D-0EF6C11521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065955-4013-9145-8EBA-474C3EB9B7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6BFF5C-B6D9-8042-99FD-E3EF4DBF4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3F609A-73D7-7A41-8D79-016D57620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82ACDA-2F0D-CC41-B43D-14FECE045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08656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B83F15-D670-5340-9F49-7A939CB6D4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424783"/>
            <a:ext cx="7886700" cy="2377281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99F2570-E14F-5D44-8388-1BAC4F7475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3824554"/>
            <a:ext cx="7886700" cy="125015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DD607F-2B41-C346-86F3-A4A963B277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F956D6-D0A4-4E41-B629-AB7F0A04F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FF8366-B5CA-304F-BBE6-7FC8CD1AD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5614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543EAC-8EAF-B64A-AE7E-92BD0D9A9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939300A-AC71-4648-B28B-274F886C65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521354"/>
            <a:ext cx="3886200" cy="3626115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E12F9D0-F281-2E43-90AC-E5C973F611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521354"/>
            <a:ext cx="3886200" cy="3626115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7986C96-8DE2-DA4E-800C-FBA385274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7403368-EEB2-6644-B71D-460A286FB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0FB6BE3-DB31-284E-8904-8AA6CD8AE9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7619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9A4ABC-026F-6C4A-A1A8-7908D917AC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04272"/>
            <a:ext cx="7886700" cy="1104636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8792F01-0DF7-7D42-9C3C-CFD7B5C8A0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400969"/>
            <a:ext cx="3868340" cy="68659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CE46C3B-3B8C-6D47-B80E-4686126739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087563"/>
            <a:ext cx="3868340" cy="3070490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DF1C830-07D9-FE46-ACC0-64794D5D94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1" y="1400969"/>
            <a:ext cx="3887391" cy="68659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C12B24D-235B-5746-9168-2DE17BA13CD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1" y="2087563"/>
            <a:ext cx="3887391" cy="3070490"/>
          </a:xfrm>
        </p:spPr>
        <p:txBody>
          <a:bodyPr/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5E09B87-D959-CF40-9C0C-55D460D1E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BF89893-7260-7D4E-8EF9-D57BD4333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0DF92DC-DD36-3646-BA46-8645E189FA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8155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868557-0407-434D-B97A-501CB5275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998D525-7B72-034D-81B2-C359B990F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A9F847B-DC39-D243-9258-CA5A279F3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14B5524-56B8-0548-9DA9-5FD119E7F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78388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A6334D4-A415-8749-AF79-DDC277817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E4C0559-5233-B744-97B8-ACB1F69BAF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9855D64-7443-844A-A774-4C46E993B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32449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4DF66D-4007-7B45-90A2-6A834FCA63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7A2922-15B4-2C4D-BEDD-FC04BB939B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822856"/>
            <a:ext cx="4629150" cy="406135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2D82EA-223A-0F43-9F75-FAC7E11273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B1EBDD7-1105-394E-9333-A0B2DA9AB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306C52-EDE7-CC41-AF91-029A7C931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617F782-C899-6744-9F3A-BC676ACE7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13001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6823A8-E791-3E4B-AED6-1D60D5A49F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E034308-697F-814C-8BE1-7F4C82AF88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822856"/>
            <a:ext cx="4629150" cy="4061354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814682F-779E-3845-8829-09DD678DD8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18EE52-8DFA-F54D-8E31-3AFD42877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4DAE29D-8FBE-8343-B85D-096F55F6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7C3508-1BA1-7344-94AA-5C5BBD519C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728207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D6CD43E-450D-6342-9B7F-69E5865E18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04272"/>
            <a:ext cx="7886700" cy="1104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C70C094-96BA-C346-A341-7863728437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521354"/>
            <a:ext cx="7886700" cy="3626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zh-CN" altLang="en-US"/>
              <a:t>编辑母版文本样式
第二级
第三级
第四级
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0298E1F-BAE5-6D4A-A310-EB144E0467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5296960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2F2E6-D461-B447-8874-E2437AC9A44E}" type="datetimeFigureOut">
              <a:rPr kumimoji="1" lang="zh-CN" altLang="en-US" smtClean="0"/>
              <a:t>2020/12/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F8C3561-BA9C-844E-8177-B87F0917CD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5296960"/>
            <a:ext cx="30861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3212CD-0E4F-6145-A50A-E2CC82C1EB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5296960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0791D7-E320-6E42-A0D5-230B51419304}" type="slidenum">
              <a:rPr kumimoji="1" lang="zh-CN" altLang="en-US" smtClean="0"/>
              <a:t>‹Nr.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08058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emf"/><Relationship Id="rId4" Type="http://schemas.openxmlformats.org/officeDocument/2006/relationships/image" Target="../media/image28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7" Type="http://schemas.openxmlformats.org/officeDocument/2006/relationships/image" Target="../media/image35.png"/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4.png"/><Relationship Id="rId5" Type="http://schemas.openxmlformats.org/officeDocument/2006/relationships/image" Target="../media/image33.emf"/><Relationship Id="rId4" Type="http://schemas.openxmlformats.org/officeDocument/2006/relationships/image" Target="../media/image3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EDACD7F3-E43A-0949-B179-2F0325DC78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2699" y="0"/>
            <a:ext cx="4298602" cy="5715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763984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86781" y="5162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652821" y="577832"/>
            <a:ext cx="37032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Choline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binding</a:t>
            </a:r>
            <a:r>
              <a:rPr lang="de-DE" sz="1400" b="1" dirty="0">
                <a:latin typeface="Arial"/>
                <a:cs typeface="Arial"/>
              </a:rPr>
              <a:t> Domains </a:t>
            </a:r>
            <a:r>
              <a:rPr lang="de-DE" sz="1400" b="1" dirty="0" err="1">
                <a:latin typeface="Arial"/>
                <a:cs typeface="Arial"/>
              </a:rPr>
              <a:t>of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PspC</a:t>
            </a:r>
            <a:r>
              <a:rPr lang="de-DE" sz="1400" b="1" dirty="0">
                <a:latin typeface="Arial"/>
                <a:cs typeface="Arial"/>
              </a:rPr>
              <a:t> variant</a:t>
            </a:r>
          </a:p>
        </p:txBody>
      </p:sp>
      <p:sp>
        <p:nvSpPr>
          <p:cNvPr id="4" name="Rechteck 3"/>
          <p:cNvSpPr/>
          <p:nvPr/>
        </p:nvSpPr>
        <p:spPr>
          <a:xfrm>
            <a:off x="86782" y="32189"/>
            <a:ext cx="67933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9: </a:t>
            </a:r>
            <a:r>
              <a:rPr lang="en-US" b="1">
                <a:latin typeface="Arial"/>
                <a:cs typeface="Arial"/>
              </a:rPr>
              <a:t>Sequence Variation of </a:t>
            </a:r>
            <a:r>
              <a:rPr lang="en-US" b="1" dirty="0">
                <a:latin typeface="Arial"/>
                <a:cs typeface="Arial"/>
              </a:rPr>
              <a:t>C-terminal Anchors</a:t>
            </a:r>
            <a:endParaRPr lang="de-DE" b="1" dirty="0">
              <a:latin typeface="Arial"/>
              <a:cs typeface="Arial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86781" y="331018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652821" y="3412591"/>
            <a:ext cx="2824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LPsTG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Anchors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of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Hic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Variants</a:t>
            </a:r>
            <a:endParaRPr lang="de-DE" sz="1400" b="1" dirty="0">
              <a:latin typeface="Arial"/>
              <a:cs typeface="Arial"/>
            </a:endParaRPr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821" y="3959018"/>
            <a:ext cx="8181975" cy="914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" y="926464"/>
            <a:ext cx="8997694" cy="10621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6166" y="2084009"/>
            <a:ext cx="8398240" cy="9936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4244"/>
          <a:stretch/>
        </p:blipFill>
        <p:spPr bwMode="auto">
          <a:xfrm>
            <a:off x="-999" y="2001067"/>
            <a:ext cx="517905" cy="10621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343530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823531" y="0"/>
            <a:ext cx="4507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Suppl. Figure 1: Structure of </a:t>
            </a:r>
            <a:r>
              <a:rPr lang="en-US" sz="1600" b="1" dirty="0" err="1">
                <a:latin typeface="Arial"/>
                <a:cs typeface="Arial"/>
              </a:rPr>
              <a:t>PspC</a:t>
            </a:r>
            <a:r>
              <a:rPr lang="en-US" sz="1600" b="1" dirty="0">
                <a:latin typeface="Arial"/>
                <a:cs typeface="Arial"/>
              </a:rPr>
              <a:t> Variants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534" y="528850"/>
            <a:ext cx="2085201" cy="20379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8225" y="528851"/>
            <a:ext cx="2059585" cy="20119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57862" y="528850"/>
            <a:ext cx="2121918" cy="22832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08521" y="3163000"/>
            <a:ext cx="2121918" cy="24831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6" name="图片 5">
            <a:extLst>
              <a:ext uri="{FF2B5EF4-FFF2-40B4-BE49-F238E27FC236}">
                <a16:creationId xmlns:a16="http://schemas.microsoft.com/office/drawing/2014/main" id="{E17F1D01-8C47-BD45-9B71-D7D66A4C542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35" t="10748" r="2572" b="1170"/>
          <a:stretch/>
        </p:blipFill>
        <p:spPr>
          <a:xfrm>
            <a:off x="4885596" y="3163000"/>
            <a:ext cx="2124480" cy="2140523"/>
          </a:xfrm>
          <a:prstGeom prst="rect">
            <a:avLst/>
          </a:prstGeom>
        </p:spPr>
      </p:pic>
      <p:cxnSp>
        <p:nvCxnSpPr>
          <p:cNvPr id="28" name="Gerade Verbindung 27">
            <a:extLst>
              <a:ext uri="{FF2B5EF4-FFF2-40B4-BE49-F238E27FC236}">
                <a16:creationId xmlns:a16="http://schemas.microsoft.com/office/drawing/2014/main" id="{12FFF633-D712-2945-8D19-4C332F73341B}"/>
              </a:ext>
            </a:extLst>
          </p:cNvPr>
          <p:cNvCxnSpPr>
            <a:cxnSpLocks/>
          </p:cNvCxnSpPr>
          <p:nvPr/>
        </p:nvCxnSpPr>
        <p:spPr>
          <a:xfrm flipV="1">
            <a:off x="12203395" y="3463890"/>
            <a:ext cx="0" cy="305168"/>
          </a:xfrm>
          <a:prstGeom prst="line">
            <a:avLst/>
          </a:prstGeom>
          <a:ln w="38100" cmpd="sng">
            <a:solidFill>
              <a:schemeClr val="tx1">
                <a:lumMod val="65000"/>
                <a:lumOff val="3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chteck 28">
            <a:extLst>
              <a:ext uri="{FF2B5EF4-FFF2-40B4-BE49-F238E27FC236}">
                <a16:creationId xmlns:a16="http://schemas.microsoft.com/office/drawing/2014/main" id="{61A08623-070D-CA4E-9792-A5BF21B2507B}"/>
              </a:ext>
            </a:extLst>
          </p:cNvPr>
          <p:cNvSpPr/>
          <p:nvPr/>
        </p:nvSpPr>
        <p:spPr>
          <a:xfrm>
            <a:off x="9818965" y="657857"/>
            <a:ext cx="1743680" cy="395456"/>
          </a:xfrm>
          <a:prstGeom prst="rect">
            <a:avLst/>
          </a:prstGeom>
          <a:solidFill>
            <a:srgbClr val="F2F2F2">
              <a:alpha val="5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1EF933B5-9F2D-B54E-B450-BA0F35F304CE}"/>
              </a:ext>
            </a:extLst>
          </p:cNvPr>
          <p:cNvSpPr txBox="1"/>
          <p:nvPr/>
        </p:nvSpPr>
        <p:spPr>
          <a:xfrm>
            <a:off x="94096" y="48625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A1062375-BADA-DC4B-8EB3-E54B9044DE76}"/>
              </a:ext>
            </a:extLst>
          </p:cNvPr>
          <p:cNvSpPr txBox="1"/>
          <p:nvPr/>
        </p:nvSpPr>
        <p:spPr>
          <a:xfrm>
            <a:off x="5947836" y="486253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C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8EC4A51-71BF-BA49-B475-FC970C1D6A3C}"/>
              </a:ext>
            </a:extLst>
          </p:cNvPr>
          <p:cNvSpPr txBox="1"/>
          <p:nvPr/>
        </p:nvSpPr>
        <p:spPr>
          <a:xfrm>
            <a:off x="2978961" y="486253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A0C8362F-BB9C-B642-A976-8117D264F05A}"/>
              </a:ext>
            </a:extLst>
          </p:cNvPr>
          <p:cNvSpPr txBox="1"/>
          <p:nvPr/>
        </p:nvSpPr>
        <p:spPr>
          <a:xfrm>
            <a:off x="1559420" y="309455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D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935E89AE-E2D3-C449-BCD9-B541AC9CF4FA}"/>
              </a:ext>
            </a:extLst>
          </p:cNvPr>
          <p:cNvSpPr txBox="1"/>
          <p:nvPr/>
        </p:nvSpPr>
        <p:spPr>
          <a:xfrm>
            <a:off x="4567291" y="309455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E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50387B3-FD47-4D40-8B59-5D175A5564E3}"/>
              </a:ext>
            </a:extLst>
          </p:cNvPr>
          <p:cNvSpPr txBox="1"/>
          <p:nvPr/>
        </p:nvSpPr>
        <p:spPr>
          <a:xfrm>
            <a:off x="1910786" y="325424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/>
                <a:cs typeface="Arial"/>
              </a:rPr>
              <a:t>PspC6.1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41CAE883-B491-F54F-BF18-1CFBF2E5F653}"/>
              </a:ext>
            </a:extLst>
          </p:cNvPr>
          <p:cNvSpPr txBox="1"/>
          <p:nvPr/>
        </p:nvSpPr>
        <p:spPr>
          <a:xfrm>
            <a:off x="4757008" y="325424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/>
                <a:cs typeface="Arial"/>
              </a:rPr>
              <a:t>PspC2.2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13F528B-8E2A-BA41-8BA9-476A4C3B1CE3}"/>
              </a:ext>
            </a:extLst>
          </p:cNvPr>
          <p:cNvSpPr txBox="1"/>
          <p:nvPr/>
        </p:nvSpPr>
        <p:spPr>
          <a:xfrm>
            <a:off x="7769350" y="325424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/>
                <a:cs typeface="Arial"/>
              </a:rPr>
              <a:t>PspC1.1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4641C3E2-B69B-3E4D-9E6C-4617CDE970BA}"/>
              </a:ext>
            </a:extLst>
          </p:cNvPr>
          <p:cNvSpPr txBox="1"/>
          <p:nvPr/>
        </p:nvSpPr>
        <p:spPr>
          <a:xfrm>
            <a:off x="3326093" y="2934273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/>
                <a:cs typeface="Arial"/>
              </a:rPr>
              <a:t>PspC5.1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13F038A7-F298-D248-8AC9-EB0F7CC0B17B}"/>
              </a:ext>
            </a:extLst>
          </p:cNvPr>
          <p:cNvSpPr txBox="1"/>
          <p:nvPr/>
        </p:nvSpPr>
        <p:spPr>
          <a:xfrm>
            <a:off x="6274436" y="2934273"/>
            <a:ext cx="7906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/>
                <a:cs typeface="Arial"/>
              </a:rPr>
              <a:t>PspC4.2</a:t>
            </a:r>
          </a:p>
        </p:txBody>
      </p:sp>
      <p:cxnSp>
        <p:nvCxnSpPr>
          <p:cNvPr id="3" name="Gerade Verbindung 2"/>
          <p:cNvCxnSpPr/>
          <p:nvPr/>
        </p:nvCxnSpPr>
        <p:spPr>
          <a:xfrm>
            <a:off x="1602009" y="1761846"/>
            <a:ext cx="0" cy="127261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 Verbindung 22"/>
          <p:cNvCxnSpPr/>
          <p:nvPr/>
        </p:nvCxnSpPr>
        <p:spPr>
          <a:xfrm>
            <a:off x="6195936" y="4588681"/>
            <a:ext cx="0" cy="127261"/>
          </a:xfrm>
          <a:prstGeom prst="line">
            <a:avLst/>
          </a:prstGeom>
          <a:ln w="19050">
            <a:solidFill>
              <a:schemeClr val="bg2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10098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07771" y="19528"/>
            <a:ext cx="5352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2: Structure of Hic/</a:t>
            </a:r>
            <a:r>
              <a:rPr lang="en-US" b="1" dirty="0" err="1">
                <a:latin typeface="Arial"/>
                <a:cs typeface="Arial"/>
              </a:rPr>
              <a:t>Psp</a:t>
            </a:r>
            <a:r>
              <a:rPr lang="en-US" b="1" dirty="0">
                <a:latin typeface="Arial"/>
                <a:cs typeface="Arial"/>
              </a:rPr>
              <a:t> variants</a:t>
            </a: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5428" y="695252"/>
            <a:ext cx="1860152" cy="23928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8739" y="688587"/>
            <a:ext cx="1965921" cy="24786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29005" y="710546"/>
            <a:ext cx="1945226" cy="21958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38323" y="3487805"/>
            <a:ext cx="1913036" cy="21046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68564" y="3485306"/>
            <a:ext cx="1901539" cy="21368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9E1FB4D5-EF72-EB46-A08D-C6AB9BFFBF48}"/>
              </a:ext>
            </a:extLst>
          </p:cNvPr>
          <p:cNvSpPr txBox="1"/>
          <p:nvPr/>
        </p:nvSpPr>
        <p:spPr>
          <a:xfrm>
            <a:off x="94096" y="71757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F30368D3-9DCA-134D-AB17-35AAAF368152}"/>
              </a:ext>
            </a:extLst>
          </p:cNvPr>
          <p:cNvSpPr txBox="1"/>
          <p:nvPr/>
        </p:nvSpPr>
        <p:spPr>
          <a:xfrm>
            <a:off x="6055072" y="71757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C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79E9AF6C-F8EE-B149-B482-C78DAD2D63F9}"/>
              </a:ext>
            </a:extLst>
          </p:cNvPr>
          <p:cNvSpPr txBox="1"/>
          <p:nvPr/>
        </p:nvSpPr>
        <p:spPr>
          <a:xfrm>
            <a:off x="3199077" y="71757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C7796F65-738E-C644-AE48-356766063918}"/>
              </a:ext>
            </a:extLst>
          </p:cNvPr>
          <p:cNvSpPr txBox="1"/>
          <p:nvPr/>
        </p:nvSpPr>
        <p:spPr>
          <a:xfrm>
            <a:off x="1559420" y="340033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D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04438091-7D8F-A840-8303-EF649B016B6F}"/>
              </a:ext>
            </a:extLst>
          </p:cNvPr>
          <p:cNvSpPr txBox="1"/>
          <p:nvPr/>
        </p:nvSpPr>
        <p:spPr>
          <a:xfrm>
            <a:off x="4567291" y="340033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E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60ACE7B3-0BED-0344-98F5-3323347A69CE}"/>
              </a:ext>
            </a:extLst>
          </p:cNvPr>
          <p:cNvSpPr txBox="1"/>
          <p:nvPr/>
        </p:nvSpPr>
        <p:spPr>
          <a:xfrm>
            <a:off x="1938131" y="485037"/>
            <a:ext cx="1072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/>
                <a:cs typeface="Arial"/>
              </a:rPr>
              <a:t>Hic</a:t>
            </a:r>
            <a:r>
              <a:rPr lang="de-DE" sz="1200" b="1" dirty="0">
                <a:latin typeface="Arial"/>
                <a:cs typeface="Arial"/>
              </a:rPr>
              <a:t>/PspC7.1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012CDA95-05ED-E64E-B97D-7F9B68A9F6BF}"/>
              </a:ext>
            </a:extLst>
          </p:cNvPr>
          <p:cNvSpPr txBox="1"/>
          <p:nvPr/>
        </p:nvSpPr>
        <p:spPr>
          <a:xfrm>
            <a:off x="4699693" y="485037"/>
            <a:ext cx="11576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/>
                <a:cs typeface="Arial"/>
              </a:rPr>
              <a:t>Hic</a:t>
            </a:r>
            <a:r>
              <a:rPr lang="de-DE" sz="1200" b="1" dirty="0">
                <a:latin typeface="Arial"/>
                <a:cs typeface="Arial"/>
              </a:rPr>
              <a:t>/PspC10.1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8B4D19D-A7AD-8D4E-995D-4C6750463ED1}"/>
              </a:ext>
            </a:extLst>
          </p:cNvPr>
          <p:cNvSpPr txBox="1"/>
          <p:nvPr/>
        </p:nvSpPr>
        <p:spPr>
          <a:xfrm>
            <a:off x="7486275" y="485037"/>
            <a:ext cx="1072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/>
                <a:cs typeface="Arial"/>
              </a:rPr>
              <a:t>Hic</a:t>
            </a:r>
            <a:r>
              <a:rPr lang="de-DE" sz="1200" b="1" dirty="0">
                <a:latin typeface="Arial"/>
                <a:cs typeface="Arial"/>
              </a:rPr>
              <a:t>/PspC9.1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5932F3E8-1039-7646-AF41-11D9FFCA59D2}"/>
              </a:ext>
            </a:extLst>
          </p:cNvPr>
          <p:cNvSpPr txBox="1"/>
          <p:nvPr/>
        </p:nvSpPr>
        <p:spPr>
          <a:xfrm>
            <a:off x="3010861" y="3259073"/>
            <a:ext cx="1072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/>
                <a:cs typeface="Arial"/>
              </a:rPr>
              <a:t>Hic</a:t>
            </a:r>
            <a:r>
              <a:rPr lang="de-DE" sz="1200" b="1" dirty="0">
                <a:latin typeface="Arial"/>
                <a:cs typeface="Arial"/>
              </a:rPr>
              <a:t>/PspC8.1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AF5E9D0-7494-9446-A844-24D97EC16E82}"/>
              </a:ext>
            </a:extLst>
          </p:cNvPr>
          <p:cNvSpPr txBox="1"/>
          <p:nvPr/>
        </p:nvSpPr>
        <p:spPr>
          <a:xfrm>
            <a:off x="6087309" y="3259073"/>
            <a:ext cx="11492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/>
                <a:cs typeface="Arial"/>
              </a:rPr>
              <a:t>Hic</a:t>
            </a:r>
            <a:r>
              <a:rPr lang="de-DE" sz="1200" b="1" dirty="0">
                <a:latin typeface="Arial"/>
                <a:cs typeface="Arial"/>
              </a:rPr>
              <a:t>/PspC11.1</a:t>
            </a:r>
          </a:p>
        </p:txBody>
      </p:sp>
    </p:spTree>
    <p:extLst>
      <p:ext uri="{BB962C8B-B14F-4D97-AF65-F5344CB8AC3E}">
        <p14:creationId xmlns:p14="http://schemas.microsoft.com/office/powerpoint/2010/main" val="5178288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437" y="54612"/>
            <a:ext cx="93282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3: Sequence Variation of the Signal Peptides &amp; Hypervariable Regions</a:t>
            </a:r>
            <a:endParaRPr lang="de-DE" b="1" dirty="0">
              <a:latin typeface="Arial"/>
              <a:cs typeface="Arial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269791" y="5162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69791" y="309554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C</a:t>
            </a:r>
          </a:p>
        </p:txBody>
      </p:sp>
      <p:pic>
        <p:nvPicPr>
          <p:cNvPr id="9" name="图片 17">
            <a:extLst>
              <a:ext uri="{FF2B5EF4-FFF2-40B4-BE49-F238E27FC236}">
                <a16:creationId xmlns:a16="http://schemas.microsoft.com/office/drawing/2014/main" id="{F126D9C2-0F72-4B44-9AB6-61C82F6018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7747" y="642886"/>
            <a:ext cx="3112726" cy="2388918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5656613" y="516277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A39006AC-707A-AC47-80CB-58F37988219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1234" y="935248"/>
            <a:ext cx="4814658" cy="1504167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097D26A5-CE6A-974C-BAF6-0E15E7E2796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9330"/>
          <a:stretch/>
        </p:blipFill>
        <p:spPr>
          <a:xfrm>
            <a:off x="237176" y="3631638"/>
            <a:ext cx="8732511" cy="1567085"/>
          </a:xfrm>
          <a:prstGeom prst="rect">
            <a:avLst/>
          </a:prstGeom>
        </p:spPr>
      </p:pic>
      <p:sp>
        <p:nvSpPr>
          <p:cNvPr id="12" name="Textfeld 11"/>
          <p:cNvSpPr txBox="1"/>
          <p:nvPr/>
        </p:nvSpPr>
        <p:spPr>
          <a:xfrm>
            <a:off x="785700" y="530907"/>
            <a:ext cx="14173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Signal Peptide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785700" y="3131243"/>
            <a:ext cx="21259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Hypervariable Domain</a:t>
            </a:r>
          </a:p>
        </p:txBody>
      </p:sp>
    </p:spTree>
    <p:extLst>
      <p:ext uri="{BB962C8B-B14F-4D97-AF65-F5344CB8AC3E}">
        <p14:creationId xmlns:p14="http://schemas.microsoft.com/office/powerpoint/2010/main" val="5563686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269791" y="5162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52324" y="240319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785700" y="530907"/>
            <a:ext cx="15872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Repeat Domain I</a:t>
            </a:r>
          </a:p>
        </p:txBody>
      </p:sp>
      <p:sp>
        <p:nvSpPr>
          <p:cNvPr id="10" name="Rechteck 9"/>
          <p:cNvSpPr/>
          <p:nvPr/>
        </p:nvSpPr>
        <p:spPr>
          <a:xfrm>
            <a:off x="42720" y="54612"/>
            <a:ext cx="6340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4: Sequence Variation of Repeat Domains</a:t>
            </a:r>
            <a:endParaRPr lang="de-DE" b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785700" y="2417821"/>
            <a:ext cx="16369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Repeat Domain II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2E9E6278-BE8D-DA4F-A1C0-EA8986002F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372269"/>
            <a:ext cx="8974667" cy="658254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0F37EF22-60D7-454B-B166-4105FC370A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748238"/>
            <a:ext cx="8974667" cy="487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10894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/>
          <p:cNvSpPr/>
          <p:nvPr/>
        </p:nvSpPr>
        <p:spPr>
          <a:xfrm>
            <a:off x="94532" y="44468"/>
            <a:ext cx="83023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5: Sequence Variation of Random Coil Domain and </a:t>
            </a:r>
            <a:r>
              <a:rPr lang="en-US" b="1" dirty="0" err="1">
                <a:latin typeface="Arial"/>
                <a:cs typeface="Arial"/>
              </a:rPr>
              <a:t>S</a:t>
            </a:r>
            <a:r>
              <a:rPr lang="en-US" b="1" baseline="-25000" dirty="0" err="1">
                <a:latin typeface="Arial"/>
                <a:cs typeface="Arial"/>
              </a:rPr>
              <a:t>n</a:t>
            </a:r>
            <a:r>
              <a:rPr lang="en-US" b="1" dirty="0" err="1">
                <a:latin typeface="Arial"/>
                <a:cs typeface="Arial"/>
              </a:rPr>
              <a:t>D</a:t>
            </a:r>
            <a:r>
              <a:rPr lang="en-US" b="1" dirty="0">
                <a:latin typeface="Arial"/>
                <a:cs typeface="Arial"/>
              </a:rPr>
              <a:t>/GS</a:t>
            </a:r>
            <a:r>
              <a:rPr lang="en-US" b="1" baseline="-25000" dirty="0">
                <a:latin typeface="Arial"/>
                <a:cs typeface="Arial"/>
              </a:rPr>
              <a:t>2</a:t>
            </a:r>
            <a:endParaRPr lang="de-DE" b="1" baseline="-25000" dirty="0">
              <a:latin typeface="Arial"/>
              <a:cs typeface="Arial"/>
            </a:endParaRP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4E110C95-6774-B344-863E-36B57432A7A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31275"/>
          <a:stretch/>
        </p:blipFill>
        <p:spPr>
          <a:xfrm>
            <a:off x="2252634" y="1000013"/>
            <a:ext cx="5516109" cy="140970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81D4BE7-A2EC-DC46-AFF5-8B5DDB1146BA}"/>
              </a:ext>
            </a:extLst>
          </p:cNvPr>
          <p:cNvSpPr txBox="1"/>
          <p:nvPr/>
        </p:nvSpPr>
        <p:spPr>
          <a:xfrm>
            <a:off x="-2425" y="5162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795585F4-7CC5-904C-89B6-34352E5F4B77}"/>
              </a:ext>
            </a:extLst>
          </p:cNvPr>
          <p:cNvSpPr txBox="1"/>
          <p:nvPr/>
        </p:nvSpPr>
        <p:spPr>
          <a:xfrm>
            <a:off x="94532" y="283106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785700" y="582112"/>
            <a:ext cx="1996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Random Coil Domain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733425" y="2896903"/>
            <a:ext cx="16257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latin typeface="Arial"/>
                <a:cs typeface="Arial"/>
              </a:rPr>
              <a:t>S</a:t>
            </a:r>
            <a:r>
              <a:rPr lang="en-US" sz="1400" b="1" baseline="-25000" dirty="0" err="1">
                <a:latin typeface="Arial"/>
                <a:cs typeface="Arial"/>
              </a:rPr>
              <a:t>n</a:t>
            </a:r>
            <a:r>
              <a:rPr lang="en-US" sz="1400" b="1" dirty="0" err="1">
                <a:latin typeface="Arial"/>
                <a:cs typeface="Arial"/>
              </a:rPr>
              <a:t>D</a:t>
            </a:r>
            <a:r>
              <a:rPr lang="en-US" sz="1400" b="1" dirty="0">
                <a:latin typeface="Arial"/>
                <a:cs typeface="Arial"/>
              </a:rPr>
              <a:t>/GS</a:t>
            </a:r>
            <a:r>
              <a:rPr lang="en-US" sz="1400" b="1" baseline="-25000" dirty="0">
                <a:latin typeface="Arial"/>
                <a:cs typeface="Arial"/>
              </a:rPr>
              <a:t>2 </a:t>
            </a:r>
            <a:r>
              <a:rPr lang="de-DE" sz="1400" b="1" dirty="0">
                <a:latin typeface="Arial"/>
                <a:cs typeface="Arial"/>
              </a:rPr>
              <a:t> Domain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7462" y="3107754"/>
            <a:ext cx="4657725" cy="2495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494829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445245" y="-12662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011285" y="-1266288"/>
            <a:ext cx="1993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Repeat Domain I</a:t>
            </a:r>
          </a:p>
        </p:txBody>
      </p:sp>
      <p:sp>
        <p:nvSpPr>
          <p:cNvPr id="4" name="Rechteck 3"/>
          <p:cNvSpPr/>
          <p:nvPr/>
        </p:nvSpPr>
        <p:spPr>
          <a:xfrm>
            <a:off x="40389" y="52935"/>
            <a:ext cx="46987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6: New N terminal Domains</a:t>
            </a:r>
            <a:endParaRPr lang="de-DE" b="1" dirty="0">
              <a:latin typeface="Arial"/>
              <a:cs typeface="Arial"/>
            </a:endParaRP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1821A6EF-ECC2-E947-9D09-40184C65DC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7553"/>
          <a:stretch/>
        </p:blipFill>
        <p:spPr>
          <a:xfrm>
            <a:off x="35560" y="743802"/>
            <a:ext cx="9144000" cy="261665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A2E923EE-8D77-6649-902F-D46180EDF85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8281"/>
          <a:stretch/>
        </p:blipFill>
        <p:spPr>
          <a:xfrm>
            <a:off x="35560" y="1451776"/>
            <a:ext cx="9057640" cy="151889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95A04149-F086-5D44-A259-198AE77AA04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5149"/>
          <a:stretch/>
        </p:blipFill>
        <p:spPr>
          <a:xfrm>
            <a:off x="35560" y="2042316"/>
            <a:ext cx="8827994" cy="346433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FFC5CA5C-1759-B341-8B80-BA91342520D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60" y="2617510"/>
            <a:ext cx="9057640" cy="432887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4D47D756-D26A-BC4F-9181-CA948FC14C2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8234"/>
          <a:stretch/>
        </p:blipFill>
        <p:spPr>
          <a:xfrm>
            <a:off x="35560" y="3517441"/>
            <a:ext cx="9057640" cy="674483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DAD000D5-80DF-AC46-8CA7-108D037EBDB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64211"/>
          <a:stretch/>
        </p:blipFill>
        <p:spPr>
          <a:xfrm>
            <a:off x="35560" y="4725269"/>
            <a:ext cx="6121400" cy="145448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D663EC70-0BAF-1F4B-AB46-855EB15CB6C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444" t="57968"/>
          <a:stretch/>
        </p:blipFill>
        <p:spPr>
          <a:xfrm>
            <a:off x="35560" y="5364081"/>
            <a:ext cx="8956967" cy="93422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id="{B81D4BE7-A2EC-DC46-AFF5-8B5DDB1146BA}"/>
              </a:ext>
            </a:extLst>
          </p:cNvPr>
          <p:cNvSpPr txBox="1"/>
          <p:nvPr/>
        </p:nvSpPr>
        <p:spPr>
          <a:xfrm>
            <a:off x="-2425" y="3862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D7BC72C5-412C-A344-8023-D6C17B862C1B}"/>
              </a:ext>
            </a:extLst>
          </p:cNvPr>
          <p:cNvSpPr txBox="1"/>
          <p:nvPr/>
        </p:nvSpPr>
        <p:spPr>
          <a:xfrm>
            <a:off x="-2425" y="167298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C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795585F4-7CC5-904C-89B6-34352E5F4B77}"/>
              </a:ext>
            </a:extLst>
          </p:cNvPr>
          <p:cNvSpPr txBox="1"/>
          <p:nvPr/>
        </p:nvSpPr>
        <p:spPr>
          <a:xfrm>
            <a:off x="-2425" y="108648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2D2C238E-D224-7541-8C6B-A9F14C537844}"/>
              </a:ext>
            </a:extLst>
          </p:cNvPr>
          <p:cNvSpPr txBox="1"/>
          <p:nvPr/>
        </p:nvSpPr>
        <p:spPr>
          <a:xfrm>
            <a:off x="-2425" y="235891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D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DCA7B34C-C381-3546-B48A-FDC1154A8C71}"/>
              </a:ext>
            </a:extLst>
          </p:cNvPr>
          <p:cNvSpPr txBox="1"/>
          <p:nvPr/>
        </p:nvSpPr>
        <p:spPr>
          <a:xfrm>
            <a:off x="-2425" y="3145708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E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98523A8E-B5F5-8C41-827B-9F29D8A18ACC}"/>
              </a:ext>
            </a:extLst>
          </p:cNvPr>
          <p:cNvSpPr txBox="1"/>
          <p:nvPr/>
        </p:nvSpPr>
        <p:spPr>
          <a:xfrm>
            <a:off x="-2425" y="435917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F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F5110F35-4581-1845-849F-161A7E739C26}"/>
              </a:ext>
            </a:extLst>
          </p:cNvPr>
          <p:cNvSpPr txBox="1"/>
          <p:nvPr/>
        </p:nvSpPr>
        <p:spPr>
          <a:xfrm>
            <a:off x="-2425" y="496522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G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31275" y="436025"/>
            <a:ext cx="31486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Random Coil Extension Domain 1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431275" y="1729182"/>
            <a:ext cx="1707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PspA</a:t>
            </a:r>
            <a:r>
              <a:rPr lang="de-DE" sz="1400" b="1" dirty="0">
                <a:latin typeface="Arial"/>
                <a:cs typeface="Arial"/>
              </a:rPr>
              <a:t>-like Domain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31275" y="1117258"/>
            <a:ext cx="31486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Random Coil Extension Domain 2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431275" y="2440374"/>
            <a:ext cx="21782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Two</a:t>
            </a:r>
            <a:r>
              <a:rPr lang="de-DE" sz="1400" b="1" dirty="0">
                <a:latin typeface="Arial"/>
                <a:cs typeface="Arial"/>
              </a:rPr>
              <a:t> </a:t>
            </a:r>
            <a:r>
              <a:rPr lang="de-DE" sz="1400" b="1" dirty="0" err="1">
                <a:latin typeface="Arial"/>
                <a:cs typeface="Arial"/>
              </a:rPr>
              <a:t>segmented</a:t>
            </a:r>
            <a:r>
              <a:rPr lang="de-DE" sz="1400" b="1" dirty="0">
                <a:latin typeface="Arial"/>
                <a:cs typeface="Arial"/>
              </a:rPr>
              <a:t> Region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431275" y="4359178"/>
            <a:ext cx="23342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PspC4.2 </a:t>
            </a:r>
            <a:r>
              <a:rPr lang="de-DE" sz="1400" b="1" dirty="0" err="1">
                <a:latin typeface="Arial"/>
                <a:cs typeface="Arial"/>
              </a:rPr>
              <a:t>Specific</a:t>
            </a:r>
            <a:r>
              <a:rPr lang="de-DE" sz="1400" b="1" dirty="0">
                <a:latin typeface="Arial"/>
                <a:cs typeface="Arial"/>
              </a:rPr>
              <a:t> Domain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431275" y="4965220"/>
            <a:ext cx="28518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Hic</a:t>
            </a:r>
            <a:r>
              <a:rPr lang="de-DE" sz="1400" b="1" dirty="0">
                <a:latin typeface="Arial"/>
                <a:cs typeface="Arial"/>
              </a:rPr>
              <a:t>/PspC11.1 </a:t>
            </a:r>
            <a:r>
              <a:rPr lang="de-DE" sz="1400" b="1" dirty="0" err="1">
                <a:latin typeface="Arial"/>
                <a:cs typeface="Arial"/>
              </a:rPr>
              <a:t>Specific</a:t>
            </a:r>
            <a:r>
              <a:rPr lang="de-DE" sz="1400" b="1" dirty="0">
                <a:latin typeface="Arial"/>
                <a:cs typeface="Arial"/>
              </a:rPr>
              <a:t> Domain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431275" y="3174071"/>
            <a:ext cx="22955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IgA</a:t>
            </a:r>
            <a:r>
              <a:rPr lang="de-DE" sz="1400" b="1" dirty="0">
                <a:latin typeface="Arial"/>
                <a:cs typeface="Arial"/>
              </a:rPr>
              <a:t> Like Binding Domain</a:t>
            </a:r>
          </a:p>
        </p:txBody>
      </p:sp>
    </p:spTree>
    <p:extLst>
      <p:ext uri="{BB962C8B-B14F-4D97-AF65-F5344CB8AC3E}">
        <p14:creationId xmlns:p14="http://schemas.microsoft.com/office/powerpoint/2010/main" val="33608414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69791" y="5162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752010" y="530907"/>
            <a:ext cx="20361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/>
                <a:cs typeface="Arial"/>
              </a:rPr>
              <a:t>Proline</a:t>
            </a:r>
            <a:r>
              <a:rPr lang="de-DE" sz="1400" b="1" dirty="0">
                <a:latin typeface="Arial"/>
                <a:cs typeface="Arial"/>
              </a:rPr>
              <a:t> Rich Domain I</a:t>
            </a:r>
          </a:p>
        </p:txBody>
      </p:sp>
      <p:sp>
        <p:nvSpPr>
          <p:cNvPr id="4" name="Rechteck 3"/>
          <p:cNvSpPr/>
          <p:nvPr/>
        </p:nvSpPr>
        <p:spPr>
          <a:xfrm>
            <a:off x="56431" y="86802"/>
            <a:ext cx="69173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7: Sequence Variation of Proline Rich Domains</a:t>
            </a:r>
            <a:endParaRPr lang="de-DE" b="1" dirty="0">
              <a:latin typeface="Arial"/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269791" y="1857552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752011" y="1872182"/>
            <a:ext cx="20858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Proline Rich Domain II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69791" y="303484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C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752011" y="3113940"/>
            <a:ext cx="21355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/>
                <a:cs typeface="Arial"/>
              </a:rPr>
              <a:t>Proline Rich Domain III</a:t>
            </a:r>
          </a:p>
        </p:txBody>
      </p:sp>
      <p:pic>
        <p:nvPicPr>
          <p:cNvPr id="12" name="Bild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5829" y="2390052"/>
            <a:ext cx="5943600" cy="275167"/>
          </a:xfrm>
          <a:prstGeom prst="rect">
            <a:avLst/>
          </a:prstGeom>
        </p:spPr>
      </p:pic>
      <p:pic>
        <p:nvPicPr>
          <p:cNvPr id="14" name="Bild 1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937613"/>
            <a:ext cx="9144000" cy="444273"/>
          </a:xfrm>
          <a:prstGeom prst="rect">
            <a:avLst/>
          </a:prstGeom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95"/>
          <a:stretch/>
        </p:blipFill>
        <p:spPr bwMode="auto">
          <a:xfrm>
            <a:off x="2230043" y="4838285"/>
            <a:ext cx="4549386" cy="6684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" name="Textfeld 15"/>
          <p:cNvSpPr txBox="1"/>
          <p:nvPr/>
        </p:nvSpPr>
        <p:spPr>
          <a:xfrm>
            <a:off x="303324" y="461704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D</a:t>
            </a:r>
          </a:p>
        </p:txBody>
      </p:sp>
      <p:pic>
        <p:nvPicPr>
          <p:cNvPr id="10" name="Grafik 9">
            <a:extLst>
              <a:ext uri="{FF2B5EF4-FFF2-40B4-BE49-F238E27FC236}">
                <a16:creationId xmlns:a16="http://schemas.microsoft.com/office/drawing/2014/main" id="{77FBC202-9DC9-8640-BE63-EC89C1A93BD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7531" y="3551108"/>
            <a:ext cx="5746110" cy="1003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15971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7302" y="12020"/>
            <a:ext cx="71994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uppl. Figure 8: Sequence Variation of Proline Rich Domains IV</a:t>
            </a:r>
            <a:endParaRPr lang="de-DE" b="1" dirty="0">
              <a:latin typeface="Arial"/>
              <a:cs typeface="Arial"/>
            </a:endParaRPr>
          </a:p>
        </p:txBody>
      </p:sp>
      <p:pic>
        <p:nvPicPr>
          <p:cNvPr id="12" name="Bild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8242" y="3056429"/>
            <a:ext cx="3278295" cy="2088395"/>
          </a:xfrm>
          <a:prstGeom prst="rect">
            <a:avLst/>
          </a:prstGeom>
        </p:spPr>
      </p:pic>
      <p:pic>
        <p:nvPicPr>
          <p:cNvPr id="13" name="Bild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8127" y="2986187"/>
            <a:ext cx="2891144" cy="2220222"/>
          </a:xfrm>
          <a:prstGeom prst="rect">
            <a:avLst/>
          </a:prstGeom>
        </p:spPr>
      </p:pic>
      <p:pic>
        <p:nvPicPr>
          <p:cNvPr id="14" name="Bild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7303" y="596879"/>
            <a:ext cx="2454038" cy="2220221"/>
          </a:xfrm>
          <a:prstGeom prst="rect">
            <a:avLst/>
          </a:prstGeom>
        </p:spPr>
      </p:pic>
      <p:pic>
        <p:nvPicPr>
          <p:cNvPr id="15" name="Bild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240" y="790289"/>
            <a:ext cx="2934854" cy="2088395"/>
          </a:xfrm>
          <a:prstGeom prst="rect">
            <a:avLst/>
          </a:prstGeom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405"/>
          <a:stretch/>
        </p:blipFill>
        <p:spPr bwMode="auto">
          <a:xfrm>
            <a:off x="6674740" y="3678957"/>
            <a:ext cx="1862252" cy="9611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" name="Picture 4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011"/>
          <a:stretch/>
        </p:blipFill>
        <p:spPr bwMode="auto">
          <a:xfrm>
            <a:off x="6593902" y="1232220"/>
            <a:ext cx="1943090" cy="9847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Textfeld 19"/>
          <p:cNvSpPr txBox="1"/>
          <p:nvPr/>
        </p:nvSpPr>
        <p:spPr>
          <a:xfrm>
            <a:off x="39790" y="50457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A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3025615" y="50457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6274047" y="50457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C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0" y="2878684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D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2985826" y="2878684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E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6234257" y="2878684"/>
            <a:ext cx="325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Arial"/>
                <a:cs typeface="Arial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4001502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8</Words>
  <Application>Microsoft Macintosh PowerPoint</Application>
  <PresentationFormat>Bildschirmpräsentation (16:10)</PresentationFormat>
  <Paragraphs>75</Paragraphs>
  <Slides>1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5" baseType="lpstr">
      <vt:lpstr>等线</vt:lpstr>
      <vt:lpstr>等线 Light</vt:lpstr>
      <vt:lpstr>Arial</vt:lpstr>
      <vt:lpstr>Calibri</vt:lpstr>
      <vt:lpstr>Office 主题​​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User</dc:creator>
  <cp:lastModifiedBy>Microsoft Office-Benutzer</cp:lastModifiedBy>
  <cp:revision>105</cp:revision>
  <cp:lastPrinted>2020-10-14T14:29:06Z</cp:lastPrinted>
  <dcterms:created xsi:type="dcterms:W3CDTF">2019-10-15T18:57:42Z</dcterms:created>
  <dcterms:modified xsi:type="dcterms:W3CDTF">2020-12-03T07:41:45Z</dcterms:modified>
</cp:coreProperties>
</file>